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68" d="100"/>
          <a:sy n="68" d="100"/>
        </p:scale>
        <p:origin x="792" y="6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1F5EF9-95E6-4113-955F-823774622FB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750713D-B992-44B6-A6CB-FE926E7776F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8115E0-5BF2-48FD-9E51-ED9F17358C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5612E4-57CA-49F8-BFAA-BE95E53DFF90}" type="datetimeFigureOut">
              <a:rPr lang="en-GB" smtClean="0"/>
              <a:t>21/07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9C267E-9B96-4CC5-B6B3-46A148D474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A89949-C0B6-4EE2-9F60-13DC33FE74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75636-2FEB-4068-B08C-7CC78C2B064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67191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189B9F-6387-4305-B4C4-6A794FB6A9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7297254-E002-4299-B080-CBF6F2406D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84E3BC-DC12-49D1-BE22-8802156ED3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5612E4-57CA-49F8-BFAA-BE95E53DFF90}" type="datetimeFigureOut">
              <a:rPr lang="en-GB" smtClean="0"/>
              <a:t>21/07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0BF7E1-77EA-4E2D-B81D-92F80C7224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B48CBF-255D-4577-B07C-D2CE2DFBA8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75636-2FEB-4068-B08C-7CC78C2B064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4510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BA25230-2871-434F-8E33-62B246583D9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27C0709-2C56-4455-9331-60109E5EB75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78E045-E657-40FC-8286-EB507D7669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5612E4-57CA-49F8-BFAA-BE95E53DFF90}" type="datetimeFigureOut">
              <a:rPr lang="en-GB" smtClean="0"/>
              <a:t>21/07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5D0A6B-E431-4CB7-B781-489B34556E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F5BC54-4AD4-4A61-950A-DF34815DD8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75636-2FEB-4068-B08C-7CC78C2B064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40140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03D8A9-9F31-492E-A1DA-2B821D551E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8E79AD6-7BFF-4E09-8D0E-FC8CA8BF8C0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58DC07-46C4-4E65-AB9E-FD27F304D6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5612E4-57CA-49F8-BFAA-BE95E53DFF90}" type="datetimeFigureOut">
              <a:rPr lang="en-GB" smtClean="0"/>
              <a:t>21/07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F4CAA1-BABA-4730-9CDB-172F52709E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17B751-DCC3-45A0-A045-D7F684B722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75636-2FEB-4068-B08C-7CC78C2B064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50922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1AB2D3-D6AE-452D-B044-307568921C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518FBE9-B31A-4A05-8B68-B05070CD03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CCEA2D-CF7E-4B8D-A4C0-8D692B17AB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5612E4-57CA-49F8-BFAA-BE95E53DFF90}" type="datetimeFigureOut">
              <a:rPr lang="en-GB" smtClean="0"/>
              <a:t>21/07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E66857-F276-409E-8D9F-5B4DE9B375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62E3EE-0F26-4115-A799-1923E9DE26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75636-2FEB-4068-B08C-7CC78C2B064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8301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702EF3-E3C3-4419-A609-8379DEC56E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24E0E0-AB76-4D99-B52F-743D336B88E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0BCF6F0-5101-4F09-B449-B8CD9B38E4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CEB858C-5B51-443F-8DA5-04D93F435E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5612E4-57CA-49F8-BFAA-BE95E53DFF90}" type="datetimeFigureOut">
              <a:rPr lang="en-GB" smtClean="0"/>
              <a:t>21/07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31C53F8-E0EF-45B7-884C-8583A9675E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040D90-3CE1-4BF0-A5FA-3F2E1F9AE9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75636-2FEB-4068-B08C-7CC78C2B064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3775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261641-4A39-498E-AC46-A55397C74B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7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A49C953-73CA-499C-B175-425C2B483A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5D72851-C2DD-4E85-9B70-1599B44172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1FA1850-8033-4DC2-A1A6-DCBEE2C2B04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45A2AF5-D76F-4EFE-AB9B-E293B24F329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470355C-B7D0-474D-884B-05BC109984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5612E4-57CA-49F8-BFAA-BE95E53DFF90}" type="datetimeFigureOut">
              <a:rPr lang="en-GB" smtClean="0"/>
              <a:t>21/07/2020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B300868-1981-4259-B2F7-0C41F19FF8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47571F6-7A06-4DD8-B565-BCE86F68F3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75636-2FEB-4068-B08C-7CC78C2B064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608154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6EE000-D9BA-478C-8A5D-DE58913D44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D75306D-AEDC-412C-84E5-EFD19B96C3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5612E4-57CA-49F8-BFAA-BE95E53DFF90}" type="datetimeFigureOut">
              <a:rPr lang="en-GB" smtClean="0"/>
              <a:t>21/07/2020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2DF69D0-A1F0-4507-94BF-AB159B93DC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2A4B94D-09DC-4594-8779-008E6D9B54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75636-2FEB-4068-B08C-7CC78C2B064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36819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7F5D337-F154-4DE3-AB98-3653D1E985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5612E4-57CA-49F8-BFAA-BE95E53DFF90}" type="datetimeFigureOut">
              <a:rPr lang="en-GB" smtClean="0"/>
              <a:t>21/07/2020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31F506E-9339-4FDB-AE25-827E6CDCB7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B806D49-CF76-41C8-BC49-1E76AAC116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75636-2FEB-4068-B08C-7CC78C2B064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00988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59B5BB-EBD7-475C-AA81-14874E9FAC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393D7D-1754-45E6-AB80-FC974FFB4E1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7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CA98AF8-2F4C-4C55-A767-CF40CCDB4A2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A93FE9-DD7D-4C72-9A43-0542622800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5612E4-57CA-49F8-BFAA-BE95E53DFF90}" type="datetimeFigureOut">
              <a:rPr lang="en-GB" smtClean="0"/>
              <a:t>21/07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55E1DB0-24F6-43E8-BE6F-A1AC8B63EB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BF8571B-3732-4FB5-8AC0-83B76844EC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75636-2FEB-4068-B08C-7CC78C2B064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67607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D984F2-5804-4FA2-9664-C6AD3F8E08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85F8F8F-191A-4FE0-A4CF-2E3DF9C3865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7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0764FB7-2F62-4325-B51F-E09ECFD563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51C177B-B36E-4AE7-9CE5-4651CDC341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5612E4-57CA-49F8-BFAA-BE95E53DFF90}" type="datetimeFigureOut">
              <a:rPr lang="en-GB" smtClean="0"/>
              <a:t>21/07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ECC89F4-A2D2-460B-93DB-3473D3F00A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ADD3D8-01D0-4019-B569-06DD79B637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75636-2FEB-4068-B08C-7CC78C2B064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31140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A4B1A4E-A2EE-4EDD-95B1-E3A39450B5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1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8A693D6-23DF-448E-B71E-54CF8A4053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1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89A779-FF78-48D2-94B8-A52FA10C373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5612E4-57CA-49F8-BFAA-BE95E53DFF90}" type="datetimeFigureOut">
              <a:rPr lang="en-GB" smtClean="0"/>
              <a:t>21/07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D560AA-D6C3-4A98-8049-D1413A9445E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1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EAFAE6-20F6-49EC-82D3-2B6E125D0DF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475636-2FEB-4068-B08C-7CC78C2B064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86159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4470830-F0D4-4522-90C5-875C9A755B6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67988" y="1612419"/>
            <a:ext cx="4086946" cy="295246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59F7E93-2616-484B-880F-534CF38BE55A}"/>
              </a:ext>
            </a:extLst>
          </p:cNvPr>
          <p:cNvSpPr txBox="1"/>
          <p:nvPr/>
        </p:nvSpPr>
        <p:spPr>
          <a:xfrm>
            <a:off x="4297153" y="1232861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  <a:endParaRPr lang="en-GB" b="1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843C5519-D4DE-4F96-B0BC-1BEC7A09EA0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01517" y="1615639"/>
            <a:ext cx="4086944" cy="2932897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2AE3DC64-E8B8-4A81-9CFB-9405A9E75EB6}"/>
              </a:ext>
            </a:extLst>
          </p:cNvPr>
          <p:cNvSpPr/>
          <p:nvPr/>
        </p:nvSpPr>
        <p:spPr>
          <a:xfrm>
            <a:off x="91395" y="5676544"/>
            <a:ext cx="1197732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Note: Climatic conditions are very similar at both location [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Chambezi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 (annual rainfall 1015mm and temperature 26.6 °C) and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Naliendele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 (1024mm and 26.3 °C)]. Mainly rainfall occurs at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Chambezi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 from March to May and October to December while, summers are much rainier than the winters at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Naliendele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. </a:t>
            </a:r>
            <a:endParaRPr lang="en-GB" sz="1200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51A881E2-DA48-462C-9A63-94F0019BE9B1}"/>
              </a:ext>
            </a:extLst>
          </p:cNvPr>
          <p:cNvSpPr/>
          <p:nvPr/>
        </p:nvSpPr>
        <p:spPr>
          <a:xfrm>
            <a:off x="229533" y="33292"/>
            <a:ext cx="11839182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20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The climate of both experimental sites (</a:t>
            </a:r>
            <a:r>
              <a:rPr lang="en-US" sz="2000" b="1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Chambezi</a:t>
            </a:r>
            <a:r>
              <a:rPr lang="en-US" sz="20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 and </a:t>
            </a:r>
            <a:r>
              <a:rPr lang="en-US" sz="2000" b="1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Naliendele</a:t>
            </a:r>
            <a:r>
              <a:rPr lang="en-US" sz="20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) in Tanzania is tropical (Rubel and </a:t>
            </a:r>
            <a:r>
              <a:rPr lang="en-US" sz="2000" b="1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Kottek</a:t>
            </a:r>
            <a:r>
              <a:rPr lang="en-US" sz="20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, 2010). The main soil type in </a:t>
            </a:r>
            <a:r>
              <a:rPr lang="en-US" sz="2000" b="1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Naliendele</a:t>
            </a:r>
            <a:r>
              <a:rPr lang="en-US" sz="20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 is reddish sands and loamy sands, while </a:t>
            </a:r>
            <a:r>
              <a:rPr lang="en-US" sz="2000" b="1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Chambezi</a:t>
            </a:r>
            <a:r>
              <a:rPr lang="en-US" sz="20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 has sandy-loam and clay soils (</a:t>
            </a:r>
            <a:r>
              <a:rPr lang="en-US" sz="2000" b="1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Mponda</a:t>
            </a:r>
            <a:r>
              <a:rPr lang="en-US" sz="20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 et al., 2001). </a:t>
            </a:r>
            <a:endParaRPr lang="en-GB" sz="2000" b="1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7A29B0D-91F6-4315-B930-D33611951EE5}"/>
              </a:ext>
            </a:extLst>
          </p:cNvPr>
          <p:cNvSpPr txBox="1"/>
          <p:nvPr/>
        </p:nvSpPr>
        <p:spPr>
          <a:xfrm>
            <a:off x="8367428" y="1227907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</a:t>
            </a:r>
            <a:endParaRPr lang="en-GB" b="1" dirty="0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855E3FA7-0C53-491F-A450-4553F2074F1F}"/>
              </a:ext>
            </a:extLst>
          </p:cNvPr>
          <p:cNvSpPr/>
          <p:nvPr/>
        </p:nvSpPr>
        <p:spPr>
          <a:xfrm>
            <a:off x="234893" y="4520021"/>
            <a:ext cx="11690324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1033463" indent="-1033463" algn="just"/>
            <a:r>
              <a:rPr lang="en-US">
                <a:solidFill>
                  <a:srgbClr val="000000"/>
                </a:solidFill>
                <a:latin typeface="Times New Roman" panose="02020603050405020304" pitchFamily="18" charset="0"/>
              </a:rPr>
              <a:t>S1 Fig: 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</a:rPr>
              <a:t>Geographical locations and climatic conditions of the experimental sites (</a:t>
            </a:r>
            <a:r>
              <a:rPr lang="en-US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Naliendele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</a:rPr>
              <a:t> and </a:t>
            </a:r>
            <a:r>
              <a:rPr lang="en-US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Chambezi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</a:rPr>
              <a:t>) in Tanzania. Geographical locations of the experimental sites (</a:t>
            </a:r>
            <a:r>
              <a:rPr lang="en-US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Naliendele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</a:rPr>
              <a:t> and </a:t>
            </a:r>
            <a:r>
              <a:rPr lang="en-US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Chambezi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</a:rPr>
              <a:t>) indicated with yellow star in the map of Tanzania (A). Climate conditions of </a:t>
            </a:r>
            <a:r>
              <a:rPr lang="en-US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Chambezi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</a:rPr>
              <a:t>, Bagamoyo region (B) and </a:t>
            </a:r>
            <a:r>
              <a:rPr lang="en-GB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Naliendele</a:t>
            </a:r>
            <a:r>
              <a:rPr lang="en-GB" dirty="0">
                <a:solidFill>
                  <a:srgbClr val="000000"/>
                </a:solidFill>
                <a:latin typeface="Times New Roman" panose="02020603050405020304" pitchFamily="18" charset="0"/>
              </a:rPr>
              <a:t>, Mtwara region (C) of 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</a:rPr>
              <a:t>Tanzania. Blue bars represent rainfall (mm) while red line denotes temperature (°C). </a:t>
            </a:r>
            <a:endParaRPr lang="en-GB" dirty="0">
              <a:solidFill>
                <a:srgbClr val="0000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1576216-6AE7-40E8-9956-7D6DE5BF35E3}"/>
              </a:ext>
            </a:extLst>
          </p:cNvPr>
          <p:cNvSpPr txBox="1"/>
          <p:nvPr/>
        </p:nvSpPr>
        <p:spPr>
          <a:xfrm>
            <a:off x="8196943" y="6387024"/>
            <a:ext cx="38717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i="1" dirty="0"/>
              <a:t>Source: </a:t>
            </a:r>
            <a:r>
              <a:rPr lang="en-GB" i="1" dirty="0"/>
              <a:t> </a:t>
            </a:r>
            <a:r>
              <a:rPr lang="en-GB" i="1" dirty="0" err="1"/>
              <a:t>Inosters</a:t>
            </a:r>
            <a:r>
              <a:rPr lang="en-GB" i="1" dirty="0"/>
              <a:t> </a:t>
            </a:r>
            <a:r>
              <a:rPr lang="en-GB" i="1" dirty="0" err="1"/>
              <a:t>Wambua</a:t>
            </a:r>
            <a:r>
              <a:rPr lang="en-GB" i="1" dirty="0"/>
              <a:t> </a:t>
            </a:r>
            <a:r>
              <a:rPr lang="en-GB" i="1" dirty="0" err="1"/>
              <a:t>Nzuki</a:t>
            </a:r>
            <a:r>
              <a:rPr lang="en-GB" i="1" dirty="0"/>
              <a:t>, 2019 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4BB37D76-1BBC-4031-BA38-96AB5F23083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9748" y="1621970"/>
            <a:ext cx="3946080" cy="2932897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60DA056E-A037-452F-8DE3-5BB15D48EE4D}"/>
              </a:ext>
            </a:extLst>
          </p:cNvPr>
          <p:cNvSpPr txBox="1"/>
          <p:nvPr/>
        </p:nvSpPr>
        <p:spPr>
          <a:xfrm>
            <a:off x="91395" y="1225883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27721296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7</TotalTime>
  <Words>194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chn off30</cp:lastModifiedBy>
  <cp:revision>10</cp:revision>
  <dcterms:created xsi:type="dcterms:W3CDTF">2020-06-05T11:48:57Z</dcterms:created>
  <dcterms:modified xsi:type="dcterms:W3CDTF">2020-07-21T18:10:35Z</dcterms:modified>
</cp:coreProperties>
</file>